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1215C5-F667-437D-ABF3-81D6C4BE68D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296311-F6A5-4695-B178-DA9B1A5A072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5024F1-BE45-4CB7-A86A-3C480665433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9268C6-C99B-406D-934A-0F16FA5ED6B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E9885E-FC87-4645-9A54-E226F05E1E7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E32121-F874-44E2-959E-93F6FE3CED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DDE12E-FFFE-425B-BE20-B39E0B0CAC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6F95D7-6214-4093-8CDC-D8B0F228D1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5477EE-820B-4689-AF3F-3E57EBA524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DC1D1E-9381-4934-B09F-D07B22B1BA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670173-87BC-459C-A3C4-9C36C0FF28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1C12DB-3081-4B67-9A6A-D8BBE3E8A7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709AAD3-9FA8-4EFF-BDED-AD93996F4DE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116000" y="4510080"/>
            <a:ext cx="756144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000" spc="-1" strike="noStrike">
                <a:solidFill>
                  <a:srgbClr val="000000"/>
                </a:solidFill>
                <a:latin typeface="Arial"/>
              </a:rPr>
              <a:t>FIGURE S2 | Relative abundance of the bacterial phyla after 7 years of chemical fertilizer and/or manure application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Arial"/>
              </a:rPr>
              <a:t>Dendrograms based on the distance between treatments along the X-axis and phylum clustering along the Y-axis are indicated in the upper and left side of the figure, respectively. Color intensity for each block represents the relative abundance of a phylum in a sample according to the color key at the bottom. Abbreviations: CF, chemical fertilizers; CF+M, chemical fertilizers plus manure; CT, control; M, manure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2197080" y="476280"/>
            <a:ext cx="4273560" cy="3817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6-06T01:30:27Z</dcterms:created>
  <dc:creator>Administrator</dc:creator>
  <dc:description/>
  <dc:language>en-US</dc:language>
  <cp:lastModifiedBy/>
  <dcterms:modified xsi:type="dcterms:W3CDTF">2017-05-23T12:08:51Z</dcterms:modified>
  <cp:revision>0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2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KSOProductBuildVer">
    <vt:lpwstr>2052-9.1.0.4472</vt:lpwstr>
  </property>
  <property fmtid="{D5CDD505-2E9C-101B-9397-08002B2CF9AE}" pid="6" name="TitleName">
    <vt:lpwstr>Presentation 2.PPT</vt:lpwstr>
  </property>
</Properties>
</file>